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png" ContentType="image/png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E2238-5E40-4C5B-B675-5F41845989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D7365-62E6-4BFC-AB15-5FB89CF111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75DD27-3730-4894-9B79-B914E1434A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338E7-B5DB-41AE-93C4-6B0CC94E44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70C30-939B-4CE0-BEA4-EAEC1C111B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3FCE5-C9B6-4507-A1F6-F55F5E8F16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2D656-0C33-4E24-8CBC-9DABFBAAA2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5C1B5-2AA5-42D1-84C4-F0034F64EE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F4A96-9E8E-4EC1-9318-9B23F47D82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E5064-6365-4E6E-A1D1-64A1CDB1EB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03625-BA41-4813-A666-6EC175C9E6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52D4C-09CD-4406-9E22-5BE984E40A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47640" indent="-2491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95400" indent="-19836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93920" indent="-1983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lstStyle>
            <a:lvl1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fld id="{C18BB13F-1C20-4145-8C9E-D9077868E6D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png"/><Relationship Id="rId8" Type="http://schemas.openxmlformats.org/officeDocument/2006/relationships/image" Target="../media/image7.wmf"/><Relationship Id="rId9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36640" y="826920"/>
            <a:ext cx="3803760" cy="6019200"/>
            <a:chOff x="836640" y="826920"/>
            <a:chExt cx="3803760" cy="6019200"/>
          </a:xfrm>
        </p:grpSpPr>
        <p:sp>
          <p:nvSpPr>
            <p:cNvPr id="42" name=""/>
            <p:cNvSpPr/>
            <p:nvPr/>
          </p:nvSpPr>
          <p:spPr>
            <a:xfrm>
              <a:off x="1938240" y="6613560"/>
              <a:ext cx="11080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408480" y="6613560"/>
              <a:ext cx="110952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836640" y="826920"/>
              <a:ext cx="3803760" cy="293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" descr=""/>
            <p:cNvPicPr/>
            <p:nvPr/>
          </p:nvPicPr>
          <p:blipFill>
            <a:blip r:embed="rId1"/>
            <a:srcRect l="9121" t="10418" r="57553" b="15810"/>
            <a:stretch/>
          </p:blipFill>
          <p:spPr>
            <a:xfrm>
              <a:off x="1832040" y="4341960"/>
              <a:ext cx="1058760" cy="98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42"/>
            <p:cNvSpPr/>
            <p:nvPr/>
          </p:nvSpPr>
          <p:spPr>
            <a:xfrm>
              <a:off x="2192400" y="4403880"/>
              <a:ext cx="106056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44"/>
            <p:cNvSpPr/>
            <p:nvPr/>
          </p:nvSpPr>
          <p:spPr>
            <a:xfrm>
              <a:off x="2448000" y="4645080"/>
              <a:ext cx="663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2"/>
            <a:srcRect l="57584" t="10418" r="9085" b="15878"/>
            <a:stretch/>
          </p:blipFill>
          <p:spPr>
            <a:xfrm>
              <a:off x="3257640" y="4341960"/>
              <a:ext cx="1060200" cy="985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3397320" y="5373720"/>
              <a:ext cx="10126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922400" y="5373720"/>
              <a:ext cx="1014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2641680" y="4626720"/>
              <a:ext cx="987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1210680" y="4674960"/>
              <a:ext cx="98892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3213000" y="4387680"/>
              <a:ext cx="0" cy="8049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97320" y="537372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1782720" y="4387680"/>
              <a:ext cx="0" cy="8049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68480" y="5373720"/>
              <a:ext cx="82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34" descr=""/>
            <p:cNvPicPr/>
            <p:nvPr/>
          </p:nvPicPr>
          <p:blipFill>
            <a:blip r:embed="rId3">
              <a:grayscl/>
            </a:blip>
            <a:srcRect l="11458" t="4433" r="90" b="10495"/>
            <a:stretch/>
          </p:blipFill>
          <p:spPr>
            <a:xfrm>
              <a:off x="3271680" y="5591160"/>
              <a:ext cx="1108080" cy="98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36" descr=""/>
            <p:cNvPicPr/>
            <p:nvPr/>
          </p:nvPicPr>
          <p:blipFill>
            <a:blip r:embed="rId4">
              <a:grayscl/>
            </a:blip>
            <a:srcRect l="11533" t="4433" r="3824" b="10495"/>
            <a:stretch/>
          </p:blipFill>
          <p:spPr>
            <a:xfrm>
              <a:off x="1844640" y="5591160"/>
              <a:ext cx="1058760" cy="98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"/>
            <p:cNvSpPr/>
            <p:nvPr/>
          </p:nvSpPr>
          <p:spPr>
            <a:xfrm>
              <a:off x="878040" y="5918040"/>
              <a:ext cx="450720" cy="26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6200000">
              <a:off x="2652840" y="5879160"/>
              <a:ext cx="987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6200000">
              <a:off x="1234440" y="5924520"/>
              <a:ext cx="98892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DCA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1797120" y="5637240"/>
              <a:ext cx="0" cy="806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82880" y="662472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3224160" y="5637240"/>
              <a:ext cx="0" cy="806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408480" y="662472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836640" y="3895560"/>
              <a:ext cx="3803760" cy="293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863640" y="4397400"/>
              <a:ext cx="536400" cy="81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F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ITD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A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Picture 37" descr=""/>
            <p:cNvPicPr/>
            <p:nvPr/>
          </p:nvPicPr>
          <p:blipFill>
            <a:blip r:embed="rId5">
              <a:grayscl/>
            </a:blip>
            <a:srcRect l="11034" t="3894" r="0" b="11682"/>
            <a:stretch/>
          </p:blipFill>
          <p:spPr>
            <a:xfrm>
              <a:off x="3255840" y="2530440"/>
              <a:ext cx="1154160" cy="98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38" descr="HD5"/>
            <p:cNvPicPr/>
            <p:nvPr/>
          </p:nvPicPr>
          <p:blipFill>
            <a:blip r:embed="rId6">
              <a:grayscl/>
            </a:blip>
            <a:srcRect l="11117" t="3808" r="0" b="11768"/>
            <a:stretch/>
          </p:blipFill>
          <p:spPr>
            <a:xfrm>
              <a:off x="1828800" y="2530440"/>
              <a:ext cx="1104840" cy="986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"/>
            <p:cNvSpPr/>
            <p:nvPr/>
          </p:nvSpPr>
          <p:spPr>
            <a:xfrm flipV="1">
              <a:off x="1782720" y="2619000"/>
              <a:ext cx="0" cy="808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919160" y="3606840"/>
              <a:ext cx="83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6200000">
              <a:off x="1209960" y="2810520"/>
              <a:ext cx="987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LA-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6200000">
              <a:off x="2638800" y="2812680"/>
              <a:ext cx="98712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381400" y="2573280"/>
              <a:ext cx="920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381400" y="3024360"/>
              <a:ext cx="920520" cy="492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874880" y="2573280"/>
              <a:ext cx="506520" cy="45108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3209760" y="2617920"/>
              <a:ext cx="0" cy="807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392640" y="360684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887400" y="2933640"/>
              <a:ext cx="452520" cy="26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" descr=""/>
            <p:cNvPicPr/>
            <p:nvPr/>
          </p:nvPicPr>
          <p:blipFill>
            <a:blip r:embed="rId7"/>
            <a:srcRect l="16681" t="7550" r="3306" b="14000"/>
            <a:stretch/>
          </p:blipFill>
          <p:spPr>
            <a:xfrm>
              <a:off x="3278160" y="1170000"/>
              <a:ext cx="1104840" cy="98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" descr=""/>
            <p:cNvPicPr/>
            <p:nvPr/>
          </p:nvPicPr>
          <p:blipFill>
            <a:blip r:embed="rId8"/>
            <a:srcRect l="12957" t="7798" r="12743" b="13558"/>
            <a:stretch/>
          </p:blipFill>
          <p:spPr>
            <a:xfrm>
              <a:off x="1851120" y="1170000"/>
              <a:ext cx="1058760" cy="98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 Box 39"/>
            <p:cNvSpPr/>
            <p:nvPr/>
          </p:nvSpPr>
          <p:spPr>
            <a:xfrm>
              <a:off x="3251160" y="1214280"/>
              <a:ext cx="4222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39"/>
            <p:cNvSpPr/>
            <p:nvPr/>
          </p:nvSpPr>
          <p:spPr>
            <a:xfrm>
              <a:off x="3643200" y="1204920"/>
              <a:ext cx="76860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/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70320" y="2249640"/>
              <a:ext cx="10126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1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895400" y="2249640"/>
              <a:ext cx="1014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895400" y="3583080"/>
              <a:ext cx="66996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370320" y="3583080"/>
              <a:ext cx="63504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1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6200000">
              <a:off x="2614680" y="1458000"/>
              <a:ext cx="987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6200000">
              <a:off x="1188000" y="1456920"/>
              <a:ext cx="98712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LA-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357280" y="1214280"/>
              <a:ext cx="920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357280" y="1665360"/>
              <a:ext cx="920880" cy="492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851120" y="1214280"/>
              <a:ext cx="552240" cy="45108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1757520" y="1260000"/>
              <a:ext cx="0" cy="808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3186000" y="1260000"/>
              <a:ext cx="0" cy="808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370320" y="224964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943280" y="2249640"/>
              <a:ext cx="830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863640" y="1276200"/>
              <a:ext cx="536400" cy="81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F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ITD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A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42"/>
            <p:cNvSpPr/>
            <p:nvPr/>
          </p:nvSpPr>
          <p:spPr>
            <a:xfrm>
              <a:off x="3695760" y="4383000"/>
              <a:ext cx="59364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39"/>
            <p:cNvSpPr/>
            <p:nvPr/>
          </p:nvSpPr>
          <p:spPr>
            <a:xfrm>
              <a:off x="3852720" y="1933560"/>
              <a:ext cx="64476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39"/>
            <p:cNvSpPr/>
            <p:nvPr/>
          </p:nvSpPr>
          <p:spPr>
            <a:xfrm>
              <a:off x="3332160" y="2536920"/>
              <a:ext cx="58896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39"/>
            <p:cNvSpPr/>
            <p:nvPr/>
          </p:nvSpPr>
          <p:spPr>
            <a:xfrm>
              <a:off x="3705120" y="2525760"/>
              <a:ext cx="91764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/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39"/>
            <p:cNvSpPr/>
            <p:nvPr/>
          </p:nvSpPr>
          <p:spPr>
            <a:xfrm>
              <a:off x="3932280" y="3301920"/>
              <a:ext cx="6364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42"/>
            <p:cNvSpPr/>
            <p:nvPr/>
          </p:nvSpPr>
          <p:spPr>
            <a:xfrm>
              <a:off x="2211480" y="5654520"/>
              <a:ext cx="106020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44"/>
            <p:cNvSpPr/>
            <p:nvPr/>
          </p:nvSpPr>
          <p:spPr>
            <a:xfrm>
              <a:off x="2496960" y="5896080"/>
              <a:ext cx="66528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42"/>
            <p:cNvSpPr/>
            <p:nvPr/>
          </p:nvSpPr>
          <p:spPr>
            <a:xfrm>
              <a:off x="3722760" y="5634000"/>
              <a:ext cx="593640" cy="23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9560" rIns="79560" tIns="39960" bIns="3996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97040"/>
                  <a:tab algn="l" pos="1593720"/>
                  <a:tab algn="l" pos="2390760"/>
                  <a:tab algn="l" pos="3187800"/>
                  <a:tab algn="l" pos="3984480"/>
                  <a:tab algn="l" pos="4781520"/>
                  <a:tab algn="l" pos="5578560"/>
                  <a:tab algn="l" pos="6375240"/>
                  <a:tab algn="l" pos="7172280"/>
                  <a:tab algn="l" pos="7969320"/>
                  <a:tab algn="l" pos="8766000"/>
                  <a:tab algn="l" pos="9563040"/>
                  <a:tab algn="l" pos="103600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"/>
          <p:cNvSpPr/>
          <p:nvPr/>
        </p:nvSpPr>
        <p:spPr>
          <a:xfrm>
            <a:off x="620640" y="179280"/>
            <a:ext cx="511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1T11:41:00Z</dcterms:created>
  <dc:creator>rickmann</dc:creator>
  <dc:description/>
  <dc:language>en-US</dc:language>
  <cp:lastModifiedBy>MHH</cp:lastModifiedBy>
  <dcterms:modified xsi:type="dcterms:W3CDTF">2012-11-27T09:58:51Z</dcterms:modified>
  <cp:revision>459</cp:revision>
  <dc:subject/>
  <dc:title>Slide 1</dc:title>
</cp:coreProperties>
</file>